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8F874B-32E2-464D-A89A-6800418D6A9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D2E223-E67D-46D9-AB67-2F916630C3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FADEC-DF86-4D4D-A57E-D2096BA1511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84939-C2F6-4437-B1B6-AF9029BBF2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64F006-4802-43F4-9526-5EF216C347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A80DAD-4CA8-43A0-8211-A88375A233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482A6-AFFD-40CF-80EA-529356B942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7BF90-AC4A-462A-84E9-E3DF4202D2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9D033B-CD5B-4FF3-BDE7-2F6CC9155F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C7605D-C616-4CB1-B186-6BD2324B8B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67779-7221-4805-8804-85FC5EC72C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8C3B05-F19C-4792-9E1E-2DC06515C1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D24FDA-2A37-4767-A5FA-65D37CC9D73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430280" y="106920"/>
            <a:ext cx="2649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5’ cuggcccucucugcccuuccgu</a:t>
            </a:r>
            <a:r>
              <a:rPr b="0" lang="en-CA" sz="2400" spc="-1" strike="noStrike">
                <a:solidFill>
                  <a:srgbClr val="000000"/>
                </a:solidFill>
                <a:latin typeface="Courier New"/>
                <a:ea typeface="宋体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633400" y="596160"/>
            <a:ext cx="328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gacgggaaggca</a:t>
            </a:r>
            <a:r>
              <a:rPr b="1" lang="en-US" sz="1200" spc="-1" strike="noStrike">
                <a:solidFill>
                  <a:srgbClr val="333399"/>
                </a:solidFill>
                <a:latin typeface="Courier New"/>
                <a:ea typeface="宋体"/>
              </a:rPr>
              <a:t>cgaatgccactacataacaat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102920" y="917640"/>
            <a:ext cx="173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5’</a:t>
            </a:r>
            <a:r>
              <a:rPr b="1" lang="en-US" sz="1200" spc="-1" strike="noStrike">
                <a:solidFill>
                  <a:srgbClr val="333399"/>
                </a:solidFill>
                <a:latin typeface="Courier New"/>
                <a:ea typeface="宋体"/>
              </a:rPr>
              <a:t>ggagatgaattct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551120" y="773280"/>
            <a:ext cx="100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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5683320" y="419760"/>
            <a:ext cx="897840" cy="927000"/>
            <a:chOff x="5683320" y="419760"/>
            <a:chExt cx="897840" cy="927000"/>
          </a:xfrm>
        </p:grpSpPr>
        <p:sp>
          <p:nvSpPr>
            <p:cNvPr id="46" name=""/>
            <p:cNvSpPr/>
            <p:nvPr/>
          </p:nvSpPr>
          <p:spPr>
            <a:xfrm>
              <a:off x="5683320" y="55764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5781960" y="46548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6120000" y="105768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936040" y="41976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694480" y="94176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301080" y="66384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807160" y="102888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954760" y="107028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080400" y="42732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309000" y="82908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6228000" y="51480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6245280" y="96228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"/>
          <p:cNvSpPr/>
          <p:nvPr/>
        </p:nvSpPr>
        <p:spPr>
          <a:xfrm>
            <a:off x="2850480" y="449280"/>
            <a:ext cx="83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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H="1">
            <a:off x="2206440" y="755640"/>
            <a:ext cx="41724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708280" y="906480"/>
            <a:ext cx="0" cy="72072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717640" y="2367000"/>
            <a:ext cx="0" cy="72072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725120" y="3539520"/>
            <a:ext cx="136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tctggccctctc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721160" y="3102840"/>
            <a:ext cx="164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ourier New"/>
                <a:ea typeface="宋体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a</a:t>
            </a:r>
            <a:r>
              <a:rPr b="0" lang="en-CA" sz="1200" spc="-1" strike="noStrike">
                <a:solidFill>
                  <a:srgbClr val="000000"/>
                </a:solidFill>
                <a:latin typeface="Courier New"/>
                <a:ea typeface="宋体"/>
              </a:rPr>
              <a:t>cc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ttt</a:t>
            </a:r>
            <a:r>
              <a:rPr b="0" lang="en-CA" sz="1200" spc="-1" strike="noStrike">
                <a:solidFill>
                  <a:srgbClr val="000000"/>
                </a:solidFill>
                <a:latin typeface="Courier New"/>
                <a:ea typeface="宋体"/>
              </a:rPr>
              <a:t>aaaaaa 5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586160" y="33886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576800" y="327420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659240" y="34520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636920" y="31647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681200" y="4720320"/>
            <a:ext cx="429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5’aattctaaattatctaatata</a:t>
            </a:r>
            <a:r>
              <a:rPr b="0" lang="en-US" sz="1200" spc="-1" strike="noStrike">
                <a:solidFill>
                  <a:srgbClr val="333399"/>
                </a:solidFill>
                <a:latin typeface="Courier New"/>
                <a:ea typeface="宋体"/>
              </a:rPr>
              <a:t>ggagatgaattctta</a:t>
            </a:r>
            <a:r>
              <a:rPr b="0" lang="en-US" sz="1200" spc="-1" strike="noStrike">
                <a:solidFill>
                  <a:srgbClr val="ff0000"/>
                </a:solidFill>
                <a:latin typeface="Courier New"/>
                <a:ea typeface="宋体"/>
              </a:rPr>
              <a:t>tgatat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048760" y="3706920"/>
            <a:ext cx="83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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799600" y="39013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Courier New"/>
                <a:ea typeface="宋体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864400" y="40172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Courier New"/>
                <a:ea typeface="宋体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894640" y="41457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Courier New"/>
                <a:ea typeface="宋体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601800" y="4416480"/>
            <a:ext cx="237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5’</a:t>
            </a:r>
            <a:r>
              <a:rPr b="1" lang="en-US" sz="1200" spc="-1" strike="noStrike">
                <a:solidFill>
                  <a:srgbClr val="333399"/>
                </a:solidFill>
                <a:latin typeface="Courier New"/>
                <a:ea typeface="宋体"/>
              </a:rPr>
              <a:t>ggagatgaattctta</a:t>
            </a:r>
            <a:r>
              <a:rPr b="1" lang="en-US" sz="1200" spc="-1" strike="noStrike">
                <a:solidFill>
                  <a:srgbClr val="ff0000"/>
                </a:solidFill>
                <a:latin typeface="Courier New"/>
                <a:ea typeface="宋体"/>
              </a:rPr>
              <a:t>tgatat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828040" y="43822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Courier New"/>
                <a:ea typeface="宋体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915520" y="429192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Courier New"/>
                <a:ea typeface="宋体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831280" y="46648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Courier New"/>
                <a:ea typeface="宋体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948640" y="46173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Courier New"/>
                <a:ea typeface="宋体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3119400" y="3674880"/>
            <a:ext cx="493920" cy="126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6202440" y="4157280"/>
            <a:ext cx="7920" cy="4208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09716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00536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18932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28148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37364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46580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55760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65120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74336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83552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92768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501984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511164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520380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29740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38956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48172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557388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66568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75784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851440" y="46530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975280" y="4611600"/>
            <a:ext cx="0" cy="15408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flipH="1">
            <a:off x="6076440" y="4508640"/>
            <a:ext cx="3240" cy="1965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739240" y="1188000"/>
            <a:ext cx="1269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Reverse transcrip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791800" y="266940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PC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694800" y="278280"/>
            <a:ext cx="61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miR-3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695880" y="646560"/>
            <a:ext cx="66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RT-328-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694440" y="3283560"/>
            <a:ext cx="753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PCR-328-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687600" y="4750200"/>
            <a:ext cx="923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PCR-miRNA-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779560" y="5006880"/>
            <a:ext cx="1800" cy="5018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246400" y="5508000"/>
            <a:ext cx="178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CR</a:t>
            </a:r>
            <a:r>
              <a:rPr b="1" lang="en-CA" sz="1200" spc="-1" strike="noStrike">
                <a:solidFill>
                  <a:srgbClr val="000000"/>
                </a:solidFill>
                <a:latin typeface="Arial"/>
                <a:ea typeface="宋体"/>
              </a:rPr>
              <a:t> product (109 bp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420560" y="1533960"/>
            <a:ext cx="2649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5’ cuggcccucucugcccuuccgu</a:t>
            </a:r>
            <a:r>
              <a:rPr b="0" lang="en-CA" sz="2400" spc="-1" strike="noStrike">
                <a:solidFill>
                  <a:srgbClr val="000000"/>
                </a:solidFill>
                <a:latin typeface="Courier New"/>
                <a:ea typeface="宋体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706040" y="2023200"/>
            <a:ext cx="4204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gaccgggagagacgggaaggca</a:t>
            </a:r>
            <a:r>
              <a:rPr b="1" lang="en-US" sz="1200" spc="-1" strike="noStrike">
                <a:solidFill>
                  <a:srgbClr val="333399"/>
                </a:solidFill>
                <a:latin typeface="Courier New"/>
                <a:ea typeface="宋体"/>
              </a:rPr>
              <a:t>cgaatgccactacataacaat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093200" y="2344680"/>
            <a:ext cx="173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5’</a:t>
            </a:r>
            <a:r>
              <a:rPr b="1" lang="en-US" sz="1200" spc="-1" strike="noStrike">
                <a:solidFill>
                  <a:srgbClr val="333399"/>
                </a:solidFill>
                <a:latin typeface="Courier New"/>
                <a:ea typeface="宋体"/>
              </a:rPr>
              <a:t>ggagatgaattct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4541760" y="2200320"/>
            <a:ext cx="100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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5" name=""/>
          <p:cNvGrpSpPr/>
          <p:nvPr/>
        </p:nvGrpSpPr>
        <p:grpSpPr>
          <a:xfrm>
            <a:off x="5673960" y="1847160"/>
            <a:ext cx="897840" cy="927360"/>
            <a:chOff x="5673960" y="1847160"/>
            <a:chExt cx="897840" cy="927360"/>
          </a:xfrm>
        </p:grpSpPr>
        <p:sp>
          <p:nvSpPr>
            <p:cNvPr id="116" name=""/>
            <p:cNvSpPr/>
            <p:nvPr/>
          </p:nvSpPr>
          <p:spPr>
            <a:xfrm>
              <a:off x="5673960" y="198540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5772600" y="189324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6110640" y="248544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5926680" y="184716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5685120" y="236952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6291720" y="209160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797800" y="245664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945400" y="249804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6071040" y="185508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6299640" y="225684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6218640" y="194220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6235920" y="2390040"/>
              <a:ext cx="27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ourier New"/>
                  <a:ea typeface="宋体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8" name=""/>
          <p:cNvSpPr/>
          <p:nvPr/>
        </p:nvSpPr>
        <p:spPr>
          <a:xfrm>
            <a:off x="2082600" y="1876320"/>
            <a:ext cx="138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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839600" y="3866400"/>
            <a:ext cx="4204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gaccgggagagacgggaaggca</a:t>
            </a:r>
            <a:r>
              <a:rPr b="1" lang="en-US" sz="1200" spc="-1" strike="noStrike">
                <a:solidFill>
                  <a:srgbClr val="333399"/>
                </a:solidFill>
                <a:latin typeface="Courier New"/>
                <a:ea typeface="宋体"/>
              </a:rPr>
              <a:t>cgaatgccactacataacaat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" descr=""/>
          <p:cNvPicPr/>
          <p:nvPr/>
        </p:nvPicPr>
        <p:blipFill>
          <a:blip r:embed="rId1"/>
          <a:stretch/>
        </p:blipFill>
        <p:spPr>
          <a:xfrm>
            <a:off x="946080" y="6602400"/>
            <a:ext cx="4714920" cy="857160"/>
          </a:xfrm>
          <a:prstGeom prst="rect">
            <a:avLst/>
          </a:prstGeom>
          <a:ln w="0">
            <a:noFill/>
          </a:ln>
        </p:spPr>
      </p:pic>
      <p:sp>
        <p:nvSpPr>
          <p:cNvPr id="131" name=""/>
          <p:cNvSpPr/>
          <p:nvPr/>
        </p:nvSpPr>
        <p:spPr>
          <a:xfrm>
            <a:off x="253800" y="1429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69800" y="60847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1447560" y="7495560"/>
            <a:ext cx="65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iR-32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582720" y="7495560"/>
            <a:ext cx="77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iR-17-3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rot="19262400">
            <a:off x="1994760" y="6275160"/>
            <a:ext cx="47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iR-32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rot="19262400">
            <a:off x="1561680" y="6338520"/>
            <a:ext cx="261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rot="19262400">
            <a:off x="2977200" y="6265800"/>
            <a:ext cx="47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iR-32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rot="19262400">
            <a:off x="2588760" y="6325920"/>
            <a:ext cx="261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rot="19262400">
            <a:off x="1192680" y="6344280"/>
            <a:ext cx="23220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H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rot="19262400">
            <a:off x="4064760" y="6296040"/>
            <a:ext cx="47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iR-32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rot="19262400">
            <a:off x="3631320" y="6359400"/>
            <a:ext cx="261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rot="19262400">
            <a:off x="5177520" y="6286680"/>
            <a:ext cx="47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iR-32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rot="19262400">
            <a:off x="4789080" y="6346440"/>
            <a:ext cx="261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568240" y="7490520"/>
            <a:ext cx="65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iR-37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4655880" y="7484400"/>
            <a:ext cx="77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iR-17-5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08T15:45:13Z</dcterms:created>
  <dc:creator>B. Yang</dc:creator>
  <dc:description/>
  <dc:language>en-US</dc:language>
  <cp:lastModifiedBy>B. Yang</cp:lastModifiedBy>
  <dcterms:modified xsi:type="dcterms:W3CDTF">2008-05-08T15:45:44Z</dcterms:modified>
  <cp:revision>1</cp:revision>
  <dc:subject/>
  <dc:title>Slide 1</dc:title>
</cp:coreProperties>
</file>